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566C7-89A7-4053-ACAA-99FFAED555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4506F-52D4-4AFB-9896-C0A7D57062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FFD17-757F-4C3C-A89B-5C9CBCC742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79139-4CE5-44BD-826A-7C4A2D6773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FF8FB-46E3-4E9F-9829-A066F0D48A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9D13A-79D1-4AE7-9A6F-E6F3453404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D1E3F-DB81-45C8-8638-BC6FE43787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6F5C7-EBA0-461B-BC45-EB043DFFB0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D83E6-5E1F-4C0E-9485-0F2D6794AF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DD7B4-52AF-419A-B9FA-40006322DC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5F23F-1484-4D3A-B2BE-691AAFA44F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D0316-3462-4F2A-9FE0-6475D62C12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644C4C-6660-43FE-B74D-8D47D148D39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9"/>
          <p:cNvSpPr/>
          <p:nvPr/>
        </p:nvSpPr>
        <p:spPr>
          <a:xfrm>
            <a:off x="777600" y="766800"/>
            <a:ext cx="3615480" cy="499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u="sng">
                <a:solidFill>
                  <a:srgbClr val="000000"/>
                </a:solidFill>
                <a:uFillTx/>
                <a:latin typeface="Arial"/>
              </a:rPr>
              <a:t>Alle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2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  at +250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AT  insert at +349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,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  at +451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  at +2463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  at +250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AT  insert at +349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,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  at +4330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  at +451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2003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  at +12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  at +250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AT  insert at +349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,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  at +4330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  at +472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Q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to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  at +4856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329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  at +12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  at +1928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AT  insert at +349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,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  at +4330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10"/>
          <p:cNvSpPr/>
          <p:nvPr/>
        </p:nvSpPr>
        <p:spPr>
          <a:xfrm>
            <a:off x="3343680" y="766800"/>
            <a:ext cx="185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400" spc="-1" strike="noStrike" u="sng">
                <a:solidFill>
                  <a:srgbClr val="000000"/>
                </a:solidFill>
                <a:uFillTx/>
                <a:latin typeface="Arial"/>
              </a:rPr>
              <a:t>Amino Acid Chan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1"/>
          <p:cNvSpPr/>
          <p:nvPr/>
        </p:nvSpPr>
        <p:spPr>
          <a:xfrm>
            <a:off x="1445400" y="766800"/>
            <a:ext cx="191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1400" spc="-1" strike="noStrike" u="sng">
                <a:solidFill>
                  <a:srgbClr val="000000"/>
                </a:solidFill>
                <a:uFillTx/>
                <a:latin typeface="Arial"/>
              </a:rPr>
              <a:t>Nucleotide change</a:t>
            </a:r>
            <a:r>
              <a:rPr b="0" lang="en-US" sz="1400" spc="-1" strike="noStrike" u="sng" baseline="30000">
                <a:solidFill>
                  <a:srgbClr val="000000"/>
                </a:solidFill>
                <a:uFillTx/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34200" y="763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4"/>
          <p:cNvSpPr/>
          <p:nvPr/>
        </p:nvSpPr>
        <p:spPr>
          <a:xfrm>
            <a:off x="438480" y="6019920"/>
            <a:ext cx="53240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quence changes in different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308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utant alleles, compar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o the Drosophila reference genome sequence.  Allele-specif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hanges are highlighted in yellow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+1 corresponds to the ‘A’ in the start codon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us308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5"/>
          <p:cNvSpPr/>
          <p:nvPr/>
        </p:nvSpPr>
        <p:spPr>
          <a:xfrm>
            <a:off x="533520" y="685800"/>
            <a:ext cx="4800600" cy="51814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1752480" y="2057400"/>
            <a:ext cx="2286000" cy="228600"/>
          </a:xfrm>
          <a:prstGeom prst="rect">
            <a:avLst/>
          </a:prstGeom>
          <a:solidFill>
            <a:srgbClr val="ffff00">
              <a:alpha val="2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1752480" y="4191120"/>
            <a:ext cx="2590920" cy="228600"/>
          </a:xfrm>
          <a:prstGeom prst="rect">
            <a:avLst/>
          </a:prstGeom>
          <a:solidFill>
            <a:srgbClr val="ffff00">
              <a:alpha val="2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1752480" y="4419720"/>
            <a:ext cx="2286000" cy="228600"/>
          </a:xfrm>
          <a:prstGeom prst="rect">
            <a:avLst/>
          </a:prstGeom>
          <a:solidFill>
            <a:srgbClr val="ffff00">
              <a:alpha val="2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0"/>
          <p:cNvSpPr/>
          <p:nvPr/>
        </p:nvSpPr>
        <p:spPr>
          <a:xfrm>
            <a:off x="1752480" y="5029200"/>
            <a:ext cx="2286000" cy="228600"/>
          </a:xfrm>
          <a:prstGeom prst="rect">
            <a:avLst/>
          </a:prstGeom>
          <a:solidFill>
            <a:srgbClr val="ffff00">
              <a:alpha val="2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05:35:14Z</dcterms:created>
  <dc:creator>Mitch McVey</dc:creator>
  <dc:description/>
  <dc:language>en-US</dc:language>
  <cp:lastModifiedBy>mmcvey01</cp:lastModifiedBy>
  <dcterms:modified xsi:type="dcterms:W3CDTF">2010-05-24T14:08:39Z</dcterms:modified>
  <cp:revision>5</cp:revision>
  <dc:subject/>
  <dc:title>Slide 1</dc:title>
</cp:coreProperties>
</file>